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8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7E0C1A6-0648-4711-8FD1-8CAF1FE044F6}" v="6" dt="2023-01-05T22:38:48.1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acomo Mangini" userId="ab8901b7774d1242" providerId="LiveId" clId="{E7E0C1A6-0648-4711-8FD1-8CAF1FE044F6}"/>
    <pc:docChg chg="undo custSel addSld delSld modSld">
      <pc:chgData name="Giacomo Mangini" userId="ab8901b7774d1242" providerId="LiveId" clId="{E7E0C1A6-0648-4711-8FD1-8CAF1FE044F6}" dt="2023-01-05T22:43:02.009" v="392"/>
      <pc:docMkLst>
        <pc:docMk/>
      </pc:docMkLst>
      <pc:sldChg chg="del">
        <pc:chgData name="Giacomo Mangini" userId="ab8901b7774d1242" providerId="LiveId" clId="{E7E0C1A6-0648-4711-8FD1-8CAF1FE044F6}" dt="2023-01-05T22:20:23.519" v="13" actId="47"/>
        <pc:sldMkLst>
          <pc:docMk/>
          <pc:sldMk cId="2849566786" sldId="256"/>
        </pc:sldMkLst>
      </pc:sldChg>
      <pc:sldChg chg="addSp delSp modSp mod">
        <pc:chgData name="Giacomo Mangini" userId="ab8901b7774d1242" providerId="LiveId" clId="{E7E0C1A6-0648-4711-8FD1-8CAF1FE044F6}" dt="2023-01-05T22:21:16.704" v="21" actId="1076"/>
        <pc:sldMkLst>
          <pc:docMk/>
          <pc:sldMk cId="3202982803" sldId="257"/>
        </pc:sldMkLst>
        <pc:spChg chg="del mod">
          <ac:chgData name="Giacomo Mangini" userId="ab8901b7774d1242" providerId="LiveId" clId="{E7E0C1A6-0648-4711-8FD1-8CAF1FE044F6}" dt="2023-01-05T22:21:02.609" v="18" actId="478"/>
          <ac:spMkLst>
            <pc:docMk/>
            <pc:sldMk cId="3202982803" sldId="257"/>
            <ac:spMk id="4" creationId="{AB9C1C4A-487E-33A2-4325-6E74B5DFE314}"/>
          </ac:spMkLst>
        </pc:spChg>
        <pc:spChg chg="add mod">
          <ac:chgData name="Giacomo Mangini" userId="ab8901b7774d1242" providerId="LiveId" clId="{E7E0C1A6-0648-4711-8FD1-8CAF1FE044F6}" dt="2023-01-05T22:21:16.704" v="21" actId="1076"/>
          <ac:spMkLst>
            <pc:docMk/>
            <pc:sldMk cId="3202982803" sldId="257"/>
            <ac:spMk id="5" creationId="{21EC8BD4-9175-0A2E-2EAE-061F719BCFE3}"/>
          </ac:spMkLst>
        </pc:spChg>
        <pc:graphicFrameChg chg="mod">
          <ac:chgData name="Giacomo Mangini" userId="ab8901b7774d1242" providerId="LiveId" clId="{E7E0C1A6-0648-4711-8FD1-8CAF1FE044F6}" dt="2023-01-05T22:21:12.934" v="20" actId="1076"/>
          <ac:graphicFrameMkLst>
            <pc:docMk/>
            <pc:sldMk cId="3202982803" sldId="257"/>
            <ac:graphicFrameMk id="2" creationId="{6392C010-F1AB-4CF3-A932-44DF864686EC}"/>
          </ac:graphicFrameMkLst>
        </pc:graphicFrameChg>
      </pc:sldChg>
      <pc:sldChg chg="addSp delSp modSp new mod">
        <pc:chgData name="Giacomo Mangini" userId="ab8901b7774d1242" providerId="LiveId" clId="{E7E0C1A6-0648-4711-8FD1-8CAF1FE044F6}" dt="2023-01-05T22:43:02.009" v="392"/>
        <pc:sldMkLst>
          <pc:docMk/>
          <pc:sldMk cId="4131125103" sldId="258"/>
        </pc:sldMkLst>
        <pc:spChg chg="add del mod">
          <ac:chgData name="Giacomo Mangini" userId="ab8901b7774d1242" providerId="LiveId" clId="{E7E0C1A6-0648-4711-8FD1-8CAF1FE044F6}" dt="2023-01-05T22:21:22.053" v="22" actId="478"/>
          <ac:spMkLst>
            <pc:docMk/>
            <pc:sldMk cId="4131125103" sldId="258"/>
            <ac:spMk id="3" creationId="{EE02EBEF-ED81-75C3-4FF6-31BE0AE2FD4E}"/>
          </ac:spMkLst>
        </pc:spChg>
        <pc:spChg chg="add mod">
          <ac:chgData name="Giacomo Mangini" userId="ab8901b7774d1242" providerId="LiveId" clId="{E7E0C1A6-0648-4711-8FD1-8CAF1FE044F6}" dt="2023-01-05T22:43:02.009" v="392"/>
          <ac:spMkLst>
            <pc:docMk/>
            <pc:sldMk cId="4131125103" sldId="258"/>
            <ac:spMk id="4" creationId="{13A4922D-D640-95D6-B38C-11DC0CF7F3B0}"/>
          </ac:spMkLst>
        </pc:spChg>
        <pc:spChg chg="add mod">
          <ac:chgData name="Giacomo Mangini" userId="ab8901b7774d1242" providerId="LiveId" clId="{E7E0C1A6-0648-4711-8FD1-8CAF1FE044F6}" dt="2023-01-05T22:42:55.934" v="390" actId="208"/>
          <ac:spMkLst>
            <pc:docMk/>
            <pc:sldMk cId="4131125103" sldId="258"/>
            <ac:spMk id="5" creationId="{C9E89C77-273F-2006-1501-1E3EDF9B650C}"/>
          </ac:spMkLst>
        </pc:spChg>
        <pc:spChg chg="add del">
          <ac:chgData name="Giacomo Mangini" userId="ab8901b7774d1242" providerId="LiveId" clId="{E7E0C1A6-0648-4711-8FD1-8CAF1FE044F6}" dt="2023-01-05T22:38:26.043" v="264" actId="478"/>
          <ac:spMkLst>
            <pc:docMk/>
            <pc:sldMk cId="4131125103" sldId="258"/>
            <ac:spMk id="8" creationId="{B3956D5A-8BD3-44EF-25E3-65D3B6FA795C}"/>
          </ac:spMkLst>
        </pc:spChg>
        <pc:spChg chg="add mod">
          <ac:chgData name="Giacomo Mangini" userId="ab8901b7774d1242" providerId="LiveId" clId="{E7E0C1A6-0648-4711-8FD1-8CAF1FE044F6}" dt="2023-01-05T22:42:55.934" v="390" actId="208"/>
          <ac:spMkLst>
            <pc:docMk/>
            <pc:sldMk cId="4131125103" sldId="258"/>
            <ac:spMk id="9" creationId="{125E0F44-0734-1279-E185-6BEBEF7394A8}"/>
          </ac:spMkLst>
        </pc:spChg>
        <pc:grpChg chg="add mod">
          <ac:chgData name="Giacomo Mangini" userId="ab8901b7774d1242" providerId="LiveId" clId="{E7E0C1A6-0648-4711-8FD1-8CAF1FE044F6}" dt="2023-01-05T22:38:48.152" v="268" actId="164"/>
          <ac:grpSpMkLst>
            <pc:docMk/>
            <pc:sldMk cId="4131125103" sldId="258"/>
            <ac:grpSpMk id="6" creationId="{0FF015A0-DC4E-7571-6A06-601BAA46EFB6}"/>
          </ac:grpSpMkLst>
        </pc:grpChg>
        <pc:grpChg chg="add mod">
          <ac:chgData name="Giacomo Mangini" userId="ab8901b7774d1242" providerId="LiveId" clId="{E7E0C1A6-0648-4711-8FD1-8CAF1FE044F6}" dt="2023-01-05T22:38:48.152" v="268" actId="164"/>
          <ac:grpSpMkLst>
            <pc:docMk/>
            <pc:sldMk cId="4131125103" sldId="258"/>
            <ac:grpSpMk id="10" creationId="{72F9C0D8-5D33-C243-6870-735A23750AC3}"/>
          </ac:grpSpMkLst>
        </pc:grpChg>
        <pc:picChg chg="add mod">
          <ac:chgData name="Giacomo Mangini" userId="ab8901b7774d1242" providerId="LiveId" clId="{E7E0C1A6-0648-4711-8FD1-8CAF1FE044F6}" dt="2023-01-05T22:42:55.934" v="390" actId="208"/>
          <ac:picMkLst>
            <pc:docMk/>
            <pc:sldMk cId="4131125103" sldId="258"/>
            <ac:picMk id="2" creationId="{BFE13DD7-E611-C162-B25D-5AF3B4DDC2AE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ELL_2mar22\Rogosjia_Wheat\Manuscript%20completo%20gennaio%202023\Manuscript_after%20invio%20coautori\Supplementary%20Materials_24gen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DELL_2mar22\Rogosjia_Wheat\Manuscript%20completo%20gennaio%202023\Submission%2027gen23\Major%20revision\Reviewer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130219419090028"/>
          <c:y val="0.12829324169530354"/>
          <c:w val="0.75025115019826494"/>
          <c:h val="0.71959556601816521"/>
        </c:manualLayout>
      </c:layout>
      <c:barChart>
        <c:barDir val="col"/>
        <c:grouping val="stacked"/>
        <c:varyColors val="0"/>
        <c:ser>
          <c:idx val="0"/>
          <c:order val="0"/>
          <c:spPr>
            <a:noFill/>
            <a:ln>
              <a:noFill/>
            </a:ln>
            <a:effectLst/>
          </c:spPr>
          <c:invertIfNegative val="0"/>
          <c:cat>
            <c:numRef>
              <c:f>'Figure S1'!$B$4197</c:f>
              <c:numCache>
                <c:formatCode>General</c:formatCode>
                <c:ptCount val="1"/>
              </c:numCache>
            </c:numRef>
          </c:cat>
          <c:val>
            <c:numRef>
              <c:f>'Figure S1'!$C$4197</c:f>
              <c:numCache>
                <c:formatCode>0.000</c:formatCode>
                <c:ptCount val="1"/>
                <c:pt idx="0">
                  <c:v>0.4637755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6A-4430-97D0-71522BF934F5}"/>
            </c:ext>
          </c:extLst>
        </c:ser>
        <c:ser>
          <c:idx val="1"/>
          <c:order val="1"/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percentage"/>
            <c:noEndCap val="1"/>
            <c:val val="10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igure S1'!$B$4197</c:f>
              <c:numCache>
                <c:formatCode>General</c:formatCode>
                <c:ptCount val="1"/>
              </c:numCache>
            </c:numRef>
          </c:cat>
          <c:val>
            <c:numRef>
              <c:f>'Figure S1'!$C$4198</c:f>
              <c:numCache>
                <c:formatCode>0.000</c:formatCode>
                <c:ptCount val="1"/>
                <c:pt idx="0">
                  <c:v>0.1642701775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6A-4430-97D0-71522BF934F5}"/>
            </c:ext>
          </c:extLst>
        </c:ser>
        <c:ser>
          <c:idx val="2"/>
          <c:order val="2"/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Figure S1'!$B$4197</c:f>
              <c:numCache>
                <c:formatCode>General</c:formatCode>
                <c:ptCount val="1"/>
              </c:numCache>
            </c:numRef>
          </c:cat>
          <c:val>
            <c:numRef>
              <c:f>'Figure S1'!$C$4199</c:f>
              <c:numCache>
                <c:formatCode>0.000</c:formatCode>
                <c:ptCount val="1"/>
                <c:pt idx="0">
                  <c:v>3.254858750000000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6A-4430-97D0-71522BF934F5}"/>
            </c:ext>
          </c:extLst>
        </c:ser>
        <c:ser>
          <c:idx val="3"/>
          <c:order val="3"/>
          <c:spPr>
            <a:solidFill>
              <a:srgbClr val="FFFF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'Figure S1'!$B$4197</c:f>
              <c:numCache>
                <c:formatCode>General</c:formatCode>
                <c:ptCount val="1"/>
              </c:numCache>
            </c:numRef>
          </c:cat>
          <c:val>
            <c:numRef>
              <c:f>'Figure S1'!$C$4200</c:f>
              <c:numCache>
                <c:formatCode>0.000</c:formatCode>
                <c:ptCount val="1"/>
                <c:pt idx="0">
                  <c:v>4.127629999999993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96A-4430-97D0-71522BF934F5}"/>
            </c:ext>
          </c:extLst>
        </c:ser>
        <c:ser>
          <c:idx val="4"/>
          <c:order val="4"/>
          <c:spPr>
            <a:noFill/>
            <a:ln>
              <a:noFill/>
            </a:ln>
            <a:effectLst/>
          </c:spPr>
          <c:invertIfNegative val="0"/>
          <c:errBars>
            <c:errBarType val="minus"/>
            <c:errValType val="percentage"/>
            <c:noEndCap val="1"/>
            <c:val val="10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Figure S1'!$B$4197</c:f>
              <c:numCache>
                <c:formatCode>General</c:formatCode>
                <c:ptCount val="1"/>
              </c:numCache>
            </c:numRef>
          </c:cat>
          <c:val>
            <c:numRef>
              <c:f>'Figure S1'!$C$4201</c:f>
              <c:numCache>
                <c:formatCode>0.000</c:formatCode>
                <c:ptCount val="1"/>
                <c:pt idx="0">
                  <c:v>0.291594436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96A-4430-97D0-71522BF93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2"/>
        <c:overlap val="100"/>
        <c:axId val="678760816"/>
        <c:axId val="678761248"/>
      </c:barChart>
      <c:catAx>
        <c:axId val="67876081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gosija collection</a:t>
                </a:r>
              </a:p>
            </c:rich>
          </c:tx>
          <c:layout>
            <c:manualLayout>
              <c:xMode val="edge"/>
              <c:yMode val="edge"/>
              <c:x val="0.48323214741535725"/>
              <c:y val="0.9208726356885212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8761248"/>
        <c:crosses val="autoZero"/>
        <c:auto val="1"/>
        <c:lblAlgn val="ctr"/>
        <c:lblOffset val="100"/>
        <c:noMultiLvlLbl val="0"/>
      </c:catAx>
      <c:valAx>
        <c:axId val="678761248"/>
        <c:scaling>
          <c:orientation val="minMax"/>
          <c:max val="1"/>
          <c:min val="0.4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BS value</a:t>
                </a:r>
              </a:p>
            </c:rich>
          </c:tx>
          <c:layout>
            <c:manualLayout>
              <c:xMode val="edge"/>
              <c:yMode val="edge"/>
              <c:x val="3.9537881027197734E-2"/>
              <c:y val="0.4268516132172833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.0" sourceLinked="0"/>
        <c:majorTickMark val="cross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78760816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823622047244092"/>
          <c:y val="6.8570332039120621E-2"/>
          <c:w val="0.81045943170147206"/>
          <c:h val="0.77204167919302535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rgbClr val="00FF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oglio1!$F$33:$F$46</c:f>
              <c:strCache>
                <c:ptCount val="14"/>
                <c:pt idx="0">
                  <c:v>1A</c:v>
                </c:pt>
                <c:pt idx="1">
                  <c:v>2A</c:v>
                </c:pt>
                <c:pt idx="2">
                  <c:v>3A</c:v>
                </c:pt>
                <c:pt idx="3">
                  <c:v>4A</c:v>
                </c:pt>
                <c:pt idx="4">
                  <c:v>5A</c:v>
                </c:pt>
                <c:pt idx="5">
                  <c:v>6A</c:v>
                </c:pt>
                <c:pt idx="6">
                  <c:v>7A</c:v>
                </c:pt>
                <c:pt idx="7">
                  <c:v>1B</c:v>
                </c:pt>
                <c:pt idx="8">
                  <c:v>2B</c:v>
                </c:pt>
                <c:pt idx="9">
                  <c:v>3B</c:v>
                </c:pt>
                <c:pt idx="10">
                  <c:v>4B</c:v>
                </c:pt>
                <c:pt idx="11">
                  <c:v>5B</c:v>
                </c:pt>
                <c:pt idx="12">
                  <c:v>6B</c:v>
                </c:pt>
                <c:pt idx="13">
                  <c:v>7B</c:v>
                </c:pt>
              </c:strCache>
            </c:strRef>
          </c:cat>
          <c:val>
            <c:numRef>
              <c:f>Foglio1!$G$33:$G$46</c:f>
              <c:numCache>
                <c:formatCode>General</c:formatCode>
                <c:ptCount val="14"/>
                <c:pt idx="0">
                  <c:v>218</c:v>
                </c:pt>
                <c:pt idx="1">
                  <c:v>230</c:v>
                </c:pt>
                <c:pt idx="2">
                  <c:v>161</c:v>
                </c:pt>
                <c:pt idx="3">
                  <c:v>151</c:v>
                </c:pt>
                <c:pt idx="4">
                  <c:v>314</c:v>
                </c:pt>
                <c:pt idx="5">
                  <c:v>272</c:v>
                </c:pt>
                <c:pt idx="6">
                  <c:v>213</c:v>
                </c:pt>
                <c:pt idx="7">
                  <c:v>290</c:v>
                </c:pt>
                <c:pt idx="8">
                  <c:v>253</c:v>
                </c:pt>
                <c:pt idx="9">
                  <c:v>252</c:v>
                </c:pt>
                <c:pt idx="10">
                  <c:v>133</c:v>
                </c:pt>
                <c:pt idx="11">
                  <c:v>305</c:v>
                </c:pt>
                <c:pt idx="12">
                  <c:v>276</c:v>
                </c:pt>
                <c:pt idx="13">
                  <c:v>2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7D-4B51-B1A3-CF156E8B72A8}"/>
            </c:ext>
          </c:extLst>
        </c:ser>
        <c:ser>
          <c:idx val="2"/>
          <c:order val="1"/>
          <c:spPr>
            <a:solidFill>
              <a:srgbClr val="CC00CC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tx2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Foglio1!$F$33:$F$46</c:f>
              <c:strCache>
                <c:ptCount val="14"/>
                <c:pt idx="0">
                  <c:v>1A</c:v>
                </c:pt>
                <c:pt idx="1">
                  <c:v>2A</c:v>
                </c:pt>
                <c:pt idx="2">
                  <c:v>3A</c:v>
                </c:pt>
                <c:pt idx="3">
                  <c:v>4A</c:v>
                </c:pt>
                <c:pt idx="4">
                  <c:v>5A</c:v>
                </c:pt>
                <c:pt idx="5">
                  <c:v>6A</c:v>
                </c:pt>
                <c:pt idx="6">
                  <c:v>7A</c:v>
                </c:pt>
                <c:pt idx="7">
                  <c:v>1B</c:v>
                </c:pt>
                <c:pt idx="8">
                  <c:v>2B</c:v>
                </c:pt>
                <c:pt idx="9">
                  <c:v>3B</c:v>
                </c:pt>
                <c:pt idx="10">
                  <c:v>4B</c:v>
                </c:pt>
                <c:pt idx="11">
                  <c:v>5B</c:v>
                </c:pt>
                <c:pt idx="12">
                  <c:v>6B</c:v>
                </c:pt>
                <c:pt idx="13">
                  <c:v>7B</c:v>
                </c:pt>
              </c:strCache>
            </c:strRef>
          </c:cat>
          <c:val>
            <c:numRef>
              <c:f>Foglio1!$H$33:$H$46</c:f>
              <c:numCache>
                <c:formatCode>General</c:formatCode>
                <c:ptCount val="14"/>
                <c:pt idx="0">
                  <c:v>490</c:v>
                </c:pt>
                <c:pt idx="1">
                  <c:v>420</c:v>
                </c:pt>
                <c:pt idx="2">
                  <c:v>371</c:v>
                </c:pt>
                <c:pt idx="3">
                  <c:v>285</c:v>
                </c:pt>
                <c:pt idx="4">
                  <c:v>482</c:v>
                </c:pt>
                <c:pt idx="5">
                  <c:v>422</c:v>
                </c:pt>
                <c:pt idx="6">
                  <c:v>553</c:v>
                </c:pt>
                <c:pt idx="7">
                  <c:v>624</c:v>
                </c:pt>
                <c:pt idx="8">
                  <c:v>506</c:v>
                </c:pt>
                <c:pt idx="9">
                  <c:v>635</c:v>
                </c:pt>
                <c:pt idx="10">
                  <c:v>234</c:v>
                </c:pt>
                <c:pt idx="11">
                  <c:v>539</c:v>
                </c:pt>
                <c:pt idx="12">
                  <c:v>536</c:v>
                </c:pt>
                <c:pt idx="13">
                  <c:v>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17D-4B51-B1A3-CF156E8B72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1685108799"/>
        <c:axId val="1685100479"/>
      </c:barChart>
      <c:catAx>
        <c:axId val="168510879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000" b="1">
                    <a:solidFill>
                      <a:sysClr val="windowText" lastClr="000000"/>
                    </a:solidFill>
                  </a:rPr>
                  <a:t>Chromosome</a:t>
                </a:r>
              </a:p>
            </c:rich>
          </c:tx>
          <c:layout>
            <c:manualLayout>
              <c:xMode val="edge"/>
              <c:yMode val="edge"/>
              <c:x val="0.50513974666210193"/>
              <c:y val="0.9220146222583265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low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100479"/>
        <c:crosses val="autoZero"/>
        <c:auto val="1"/>
        <c:lblAlgn val="ctr"/>
        <c:lblOffset val="100"/>
        <c:noMultiLvlLbl val="0"/>
      </c:catAx>
      <c:valAx>
        <c:axId val="1685100479"/>
        <c:scaling>
          <c:orientation val="minMax"/>
          <c:max val="650"/>
          <c:min val="100"/>
        </c:scaling>
        <c:delete val="0"/>
        <c:axPos val="l"/>
        <c:majorGridlines>
          <c:spPr>
            <a:ln w="9525" cap="flat" cmpd="sng" algn="ctr">
              <a:solidFill>
                <a:schemeClr val="tx2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2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000">
                    <a:solidFill>
                      <a:sysClr val="windowText" lastClr="000000"/>
                    </a:solidFill>
                  </a:rPr>
                  <a:t>Number of polymorphic SNPs</a:t>
                </a:r>
              </a:p>
            </c:rich>
          </c:tx>
          <c:layout>
            <c:manualLayout>
              <c:xMode val="edge"/>
              <c:yMode val="edge"/>
              <c:x val="2.6112975008558713E-2"/>
              <c:y val="0.2351596870862303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2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85108799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6350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7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  <a:lumOff val="2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08D7A02-E501-CFB1-2238-B3F147F1D8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55F3AAD-A10B-25E9-AD3B-1F82E8B84D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15C55A2-3D08-4682-EB04-7075E08F0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A2D289A-16E8-8C6B-7FDE-458D98836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113CA3B-CAA2-2E6D-BF7A-CCBE152A3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541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443107-DE98-4692-38CA-4C816AD78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B77E01C-FD80-0AAD-945F-338879633D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23882B-D0AC-849D-008B-66E15DA0D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D9DF331-5D02-76F8-3CD3-51AA6E1CD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8F60306-BB60-9B32-E2CB-C13D6B0C5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1065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5DB46A5-C0F6-D635-E4FB-50685272DE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005AF10-3285-6632-0744-3AC4D2D25B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EEF0FBB-69E2-1187-C60C-F15CD5CB5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F762929-650B-B11F-CDC7-C323A0162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91E707-F562-2228-8D4F-890629296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713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0C181DA-549A-3F4A-0518-FB068E85BE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8472F94-C0EA-DE9A-57C8-D28664B43B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A6E1F12-2ECB-BF18-9727-7CB257B9E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D60AA3-9FA9-844A-D0EF-08CE44E89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DEF0713-8FC3-2F78-CA41-F53C38748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8452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C98A0E8-42D9-9FCD-E117-E5B4DC9CE3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DDDF5ED-36B5-1974-F331-1CED6EABAF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F9EACB4-F2CB-8649-85F2-F02C5F50A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9800387-50D2-759D-AC62-B0FE111E9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284A80-2FA2-D335-D0D6-8A4F5AFF9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5036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968904-06FF-F651-ACDC-2A27881BDC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1FD5DBC-7C83-D209-FAA0-4E675636D8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EC20180-3C55-ED0F-105E-C5499D4C55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274699D-9238-0FC2-3670-9842D294C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8149C63-5727-88D5-5EDF-A352BE0371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63DC139-2A58-3780-4D79-8074D00A2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54811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3D2524-D667-E13A-6E60-BB4EE6CB2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D5524C2-5240-B439-D04D-8B623C1F0F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47FB40F-5F1D-F3C5-D7BE-B4A2E068C7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DEA2EE1-A71B-5C71-7026-D524A0CAF3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00AB8BE-1B8B-479D-CD08-1E31481FB4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101C208-F21D-F819-FF5C-385A234BC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0C549CA-3F1A-567E-287A-DCCEFF693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CA2DAFF-C561-56E4-6D58-57F3012A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0190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94BD0D8-0A9C-9C27-7BA5-E7B2E685DF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07D9523E-1725-2309-DC3D-6615C26B4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AB067BC-0BE0-F7F6-C9FF-4C066D2F2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FA64125-1EC7-E65E-0D56-98E71A37A8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34396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DDD3BDA-AC4C-D53C-D8C7-C5DAFA20B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433E56C-DF18-07F4-56FC-8065BAA06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E4CA8FB7-7367-11E5-0AF8-18CBCB3A1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4774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0639A6F-9695-3D60-7C1E-75CA09527A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287A76-ECE9-33E4-A752-29B0971BF7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8E25276-4F48-72C8-634F-EAF0C2F7A8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A2DC717-5171-4B89-EB22-29AC655A2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EE558E4-EBBD-5EE1-8066-DF2E8F996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20D49AF-2EC4-E25E-1111-8460663B7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083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D3EB10-EBA2-6717-377C-E02D4B487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2BE0271-D355-091C-4201-3592FC5748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3346784-E12C-B35E-85F1-279ADC2C28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34A8C51-99AF-E576-091B-582D932E8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9B71B5D-014B-2EBB-1A80-C7ACCFC56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23389C8-ED9A-082B-9E8F-57208BA9EF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1879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CEF8B9C-4236-151B-4882-7652965F7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71E633B-8EA9-D21F-3CB6-9DAB07FC49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9E42D7B-A2D1-C212-0F98-CF6CCE3B8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41B98-55D3-4061-BEB6-DEFF264379DA}" type="datetimeFigureOut">
              <a:rPr lang="it-IT" smtClean="0"/>
              <a:t>03/03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D21856-C01B-6CF4-1201-69F872AE54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ACDF182-5511-4E48-6BC1-4EF44CB84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E46C6-F459-4654-992B-D0D1C7144272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021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21EC8BD4-9175-0A2E-2EAE-061F719BCFE3}"/>
              </a:ext>
            </a:extLst>
          </p:cNvPr>
          <p:cNvSpPr txBox="1"/>
          <p:nvPr/>
        </p:nvSpPr>
        <p:spPr>
          <a:xfrm>
            <a:off x="409074" y="6072227"/>
            <a:ext cx="1137385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Palatino Linotype" panose="02040502050505030304" pitchFamily="18" charset="0"/>
              </a:rPr>
              <a:t>Figure S1. </a:t>
            </a:r>
            <a:r>
              <a:rPr lang="en-GB" sz="1200" dirty="0">
                <a:latin typeface="Palatino Linotype" panose="02040502050505030304" pitchFamily="18" charset="0"/>
              </a:rPr>
              <a:t>Box plot of Identity by State (IBS)  in “Rogosija collection” including 89 durum accessions determined by the analysis of 6,915 SNP markers.</a:t>
            </a:r>
          </a:p>
        </p:txBody>
      </p:sp>
      <p:graphicFrame>
        <p:nvGraphicFramePr>
          <p:cNvPr id="4" name="Grafic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3910742"/>
              </p:ext>
            </p:extLst>
          </p:nvPr>
        </p:nvGraphicFramePr>
        <p:xfrm>
          <a:off x="1742654" y="831273"/>
          <a:ext cx="8132884" cy="43961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02982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595AE309-FBA8-A276-E365-640B3ADBC58E}"/>
              </a:ext>
            </a:extLst>
          </p:cNvPr>
          <p:cNvSpPr txBox="1"/>
          <p:nvPr/>
        </p:nvSpPr>
        <p:spPr>
          <a:xfrm>
            <a:off x="409074" y="6072227"/>
            <a:ext cx="1137385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Palatino Linotype" panose="02040502050505030304" pitchFamily="18" charset="0"/>
              </a:rPr>
              <a:t>Figure S2. </a:t>
            </a:r>
            <a:r>
              <a:rPr lang="en-US" sz="1200" dirty="0">
                <a:latin typeface="Palatino Linotype" panose="02040502050505030304" pitchFamily="18" charset="0"/>
              </a:rPr>
              <a:t>Distribution of SNPs generated from the 25K Illumina SNPs array across the chromosome in the “Rogosija collection” (in purple) and in the foreign durum cultivars (green)</a:t>
            </a:r>
            <a:r>
              <a:rPr lang="en-GB" sz="1200" dirty="0">
                <a:latin typeface="Palatino Linotype" panose="02040502050505030304" pitchFamily="18" charset="0"/>
              </a:rPr>
              <a:t>.</a:t>
            </a:r>
          </a:p>
        </p:txBody>
      </p:sp>
      <p:graphicFrame>
        <p:nvGraphicFramePr>
          <p:cNvPr id="4" name="Grafico 3">
            <a:extLst>
              <a:ext uri="{FF2B5EF4-FFF2-40B4-BE49-F238E27FC236}">
                <a16:creationId xmlns:a16="http://schemas.microsoft.com/office/drawing/2014/main" id="{4CEA99BF-AB84-04E8-68F8-70C77CD2F2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9191228"/>
              </p:ext>
            </p:extLst>
          </p:nvPr>
        </p:nvGraphicFramePr>
        <p:xfrm>
          <a:off x="1813774" y="1003993"/>
          <a:ext cx="8132884" cy="43961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22707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3A4922D-D640-95D6-B38C-11DC0CF7F3B0}"/>
              </a:ext>
            </a:extLst>
          </p:cNvPr>
          <p:cNvSpPr txBox="1"/>
          <p:nvPr/>
        </p:nvSpPr>
        <p:spPr>
          <a:xfrm>
            <a:off x="243840" y="5861546"/>
            <a:ext cx="1186688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200" b="1" dirty="0">
                <a:latin typeface="Palatino Linotype" panose="02040502050505030304" pitchFamily="18" charset="0"/>
              </a:rPr>
              <a:t>Figure S3. </a:t>
            </a:r>
            <a:r>
              <a:rPr lang="en-GB" sz="1200" dirty="0" err="1">
                <a:latin typeface="Palatino Linotype" panose="02040502050505030304" pitchFamily="18" charset="0"/>
              </a:rPr>
              <a:t>Köppen</a:t>
            </a:r>
            <a:r>
              <a:rPr lang="en-GB" sz="1200" dirty="0">
                <a:latin typeface="Palatino Linotype" panose="02040502050505030304" pitchFamily="18" charset="0"/>
              </a:rPr>
              <a:t> climatic classification of Montenegro [</a:t>
            </a:r>
            <a:r>
              <a:rPr lang="en-GB" sz="1200" dirty="0">
                <a:solidFill>
                  <a:srgbClr val="0000FF"/>
                </a:solidFill>
                <a:latin typeface="Palatino Linotype" panose="02040502050505030304" pitchFamily="18" charset="0"/>
              </a:rPr>
              <a:t>54</a:t>
            </a:r>
            <a:r>
              <a:rPr lang="en-GB" sz="1200" dirty="0">
                <a:latin typeface="Palatino Linotype" panose="02040502050505030304" pitchFamily="18" charset="0"/>
              </a:rPr>
              <a:t>]. </a:t>
            </a:r>
            <a:r>
              <a:rPr lang="en-US" sz="1200" dirty="0" err="1">
                <a:latin typeface="Palatino Linotype" panose="02040502050505030304" pitchFamily="18" charset="0"/>
              </a:rPr>
              <a:t>Csa</a:t>
            </a:r>
            <a:r>
              <a:rPr lang="en-US" sz="1200" dirty="0">
                <a:latin typeface="Palatino Linotype" panose="02040502050505030304" pitchFamily="18" charset="0"/>
              </a:rPr>
              <a:t> = Hot-summer Mediterranean climate; </a:t>
            </a:r>
            <a:r>
              <a:rPr lang="en-US" sz="1200" dirty="0" err="1">
                <a:latin typeface="Palatino Linotype" panose="02040502050505030304" pitchFamily="18" charset="0"/>
              </a:rPr>
              <a:t>Cfsb</a:t>
            </a:r>
            <a:r>
              <a:rPr lang="en-US" sz="1200" dirty="0">
                <a:latin typeface="Palatino Linotype" panose="02040502050505030304" pitchFamily="18" charset="0"/>
              </a:rPr>
              <a:t> = </a:t>
            </a:r>
            <a:r>
              <a:rPr lang="en-US" sz="1200" dirty="0" err="1">
                <a:latin typeface="Palatino Linotype" panose="02040502050505030304" pitchFamily="18" charset="0"/>
              </a:rPr>
              <a:t>perhumid</a:t>
            </a:r>
            <a:r>
              <a:rPr lang="en-US" sz="1200" dirty="0">
                <a:latin typeface="Palatino Linotype" panose="02040502050505030304" pitchFamily="18" charset="0"/>
              </a:rPr>
              <a:t> Mediterranean mountain climate without summer dryness; </a:t>
            </a:r>
            <a:r>
              <a:rPr lang="en-US" sz="1200" dirty="0" err="1">
                <a:latin typeface="Palatino Linotype" panose="02040502050505030304" pitchFamily="18" charset="0"/>
              </a:rPr>
              <a:t>Cfs</a:t>
            </a:r>
            <a:r>
              <a:rPr lang="en-US" sz="1200" dirty="0">
                <a:latin typeface="Palatino Linotype" panose="02040502050505030304" pitchFamily="18" charset="0"/>
              </a:rPr>
              <a:t>’’b = Moderately warm Mediterranean climate without pronounced dry period during the year with dry summers; </a:t>
            </a:r>
            <a:r>
              <a:rPr lang="en-US" sz="1200" dirty="0" err="1">
                <a:latin typeface="Palatino Linotype" panose="02040502050505030304" pitchFamily="18" charset="0"/>
              </a:rPr>
              <a:t>Cfb</a:t>
            </a:r>
            <a:r>
              <a:rPr lang="en-US" sz="1200" dirty="0">
                <a:latin typeface="Palatino Linotype" panose="02040502050505030304" pitchFamily="18" charset="0"/>
              </a:rPr>
              <a:t> = Temperate oceanic climate; </a:t>
            </a:r>
            <a:r>
              <a:rPr lang="en-US" sz="1200" dirty="0" err="1">
                <a:latin typeface="Palatino Linotype" panose="02040502050505030304" pitchFamily="18" charset="0"/>
              </a:rPr>
              <a:t>Cfwas</a:t>
            </a:r>
            <a:r>
              <a:rPr lang="en-US" sz="1200" dirty="0">
                <a:latin typeface="Palatino Linotype" panose="02040502050505030304" pitchFamily="18" charset="0"/>
              </a:rPr>
              <a:t>’’Bx’’ = Moderately temperate climate without pronounced dry period during the year with less precipitation in the winter part of the year and </a:t>
            </a:r>
            <a:r>
              <a:rPr lang="en-US" sz="1200" dirty="0" err="1">
                <a:latin typeface="Palatino Linotype" panose="02040502050505030304" pitchFamily="18" charset="0"/>
              </a:rPr>
              <a:t>Dfbx</a:t>
            </a:r>
            <a:r>
              <a:rPr lang="en-US" sz="1200" dirty="0">
                <a:latin typeface="Palatino Linotype" panose="02040502050505030304" pitchFamily="18" charset="0"/>
              </a:rPr>
              <a:t>’’ = Warm-summer humid continental climate.</a:t>
            </a:r>
            <a:endParaRPr lang="en-GB" dirty="0">
              <a:latin typeface="Palatino Linotype" panose="02040502050505030304" pitchFamily="18" charset="0"/>
            </a:endParaRPr>
          </a:p>
        </p:txBody>
      </p:sp>
      <p:grpSp>
        <p:nvGrpSpPr>
          <p:cNvPr id="7" name="Gruppo 6">
            <a:extLst>
              <a:ext uri="{FF2B5EF4-FFF2-40B4-BE49-F238E27FC236}">
                <a16:creationId xmlns:a16="http://schemas.microsoft.com/office/drawing/2014/main" id="{61C5CD54-CFA1-A0AC-7D9D-ABA4E647B43A}"/>
              </a:ext>
            </a:extLst>
          </p:cNvPr>
          <p:cNvGrpSpPr/>
          <p:nvPr/>
        </p:nvGrpSpPr>
        <p:grpSpPr>
          <a:xfrm>
            <a:off x="3464560" y="165457"/>
            <a:ext cx="5720080" cy="5581650"/>
            <a:chOff x="3464560" y="165457"/>
            <a:chExt cx="5720080" cy="5581650"/>
          </a:xfrm>
        </p:grpSpPr>
        <p:grpSp>
          <p:nvGrpSpPr>
            <p:cNvPr id="10" name="Gruppo 9">
              <a:extLst>
                <a:ext uri="{FF2B5EF4-FFF2-40B4-BE49-F238E27FC236}">
                  <a16:creationId xmlns:a16="http://schemas.microsoft.com/office/drawing/2014/main" id="{72F9C0D8-5D33-C243-6870-735A23750AC3}"/>
                </a:ext>
              </a:extLst>
            </p:cNvPr>
            <p:cNvGrpSpPr/>
            <p:nvPr/>
          </p:nvGrpSpPr>
          <p:grpSpPr>
            <a:xfrm>
              <a:off x="3766185" y="165457"/>
              <a:ext cx="5086350" cy="5581650"/>
              <a:chOff x="3552825" y="490577"/>
              <a:chExt cx="5086350" cy="5581650"/>
            </a:xfrm>
          </p:grpSpPr>
          <p:grpSp>
            <p:nvGrpSpPr>
              <p:cNvPr id="6" name="Gruppo 5">
                <a:extLst>
                  <a:ext uri="{FF2B5EF4-FFF2-40B4-BE49-F238E27FC236}">
                    <a16:creationId xmlns:a16="http://schemas.microsoft.com/office/drawing/2014/main" id="{0FF015A0-DC4E-7571-6A06-601BAA46EFB6}"/>
                  </a:ext>
                </a:extLst>
              </p:cNvPr>
              <p:cNvGrpSpPr/>
              <p:nvPr/>
            </p:nvGrpSpPr>
            <p:grpSpPr>
              <a:xfrm>
                <a:off x="3552825" y="490577"/>
                <a:ext cx="5086350" cy="5581650"/>
                <a:chOff x="3552825" y="231775"/>
                <a:chExt cx="5086350" cy="5581650"/>
              </a:xfrm>
            </p:grpSpPr>
            <p:pic>
              <p:nvPicPr>
                <p:cNvPr id="2" name="image3.png">
                  <a:extLst>
                    <a:ext uri="{FF2B5EF4-FFF2-40B4-BE49-F238E27FC236}">
                      <a16:creationId xmlns:a16="http://schemas.microsoft.com/office/drawing/2014/main" id="{BFE13DD7-E611-C162-B25D-5AF3B4DDC2AE}"/>
                    </a:ext>
                  </a:extLst>
                </p:cNvPr>
                <p:cNvPicPr/>
                <p:nvPr/>
              </p:nvPicPr>
              <p:blipFill>
                <a:blip r:embed="rId2" cstate="print"/>
                <a:srcRect/>
                <a:stretch>
                  <a:fillRect/>
                </a:stretch>
              </p:blipFill>
              <p:spPr>
                <a:xfrm>
                  <a:off x="3552825" y="231775"/>
                  <a:ext cx="5086350" cy="5581650"/>
                </a:xfrm>
                <a:prstGeom prst="rect">
                  <a:avLst/>
                </a:prstGeom>
                <a:ln/>
              </p:spPr>
            </p:pic>
            <p:sp>
              <p:nvSpPr>
                <p:cNvPr id="5" name="Rettangolo 4">
                  <a:extLst>
                    <a:ext uri="{FF2B5EF4-FFF2-40B4-BE49-F238E27FC236}">
                      <a16:creationId xmlns:a16="http://schemas.microsoft.com/office/drawing/2014/main" id="{C9E89C77-273F-2006-1501-1E3EDF9B650C}"/>
                    </a:ext>
                  </a:extLst>
                </p:cNvPr>
                <p:cNvSpPr/>
                <p:nvPr/>
              </p:nvSpPr>
              <p:spPr>
                <a:xfrm>
                  <a:off x="3552825" y="5410200"/>
                  <a:ext cx="2174875" cy="40322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9" name="Rettangolo 8">
                <a:extLst>
                  <a:ext uri="{FF2B5EF4-FFF2-40B4-BE49-F238E27FC236}">
                    <a16:creationId xmlns:a16="http://schemas.microsoft.com/office/drawing/2014/main" id="{125E0F44-0734-1279-E185-6BEBEF7394A8}"/>
                  </a:ext>
                </a:extLst>
              </p:cNvPr>
              <p:cNvSpPr/>
              <p:nvPr/>
            </p:nvSpPr>
            <p:spPr>
              <a:xfrm>
                <a:off x="6634716" y="4295553"/>
                <a:ext cx="878958" cy="17012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3" name="Rettangolo 2">
              <a:extLst>
                <a:ext uri="{FF2B5EF4-FFF2-40B4-BE49-F238E27FC236}">
                  <a16:creationId xmlns:a16="http://schemas.microsoft.com/office/drawing/2014/main" id="{D5F6A343-6E02-3A42-0B18-08682A4130E5}"/>
                </a:ext>
              </a:extLst>
            </p:cNvPr>
            <p:cNvSpPr/>
            <p:nvPr/>
          </p:nvSpPr>
          <p:spPr>
            <a:xfrm>
              <a:off x="3464560" y="165457"/>
              <a:ext cx="5720080" cy="54936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41311251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</TotalTime>
  <Words>161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i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acomo Mangini</dc:creator>
  <cp:lastModifiedBy>MDPI</cp:lastModifiedBy>
  <cp:revision>18</cp:revision>
  <dcterms:created xsi:type="dcterms:W3CDTF">2023-01-05T21:46:20Z</dcterms:created>
  <dcterms:modified xsi:type="dcterms:W3CDTF">2023-03-03T05:47:15Z</dcterms:modified>
</cp:coreProperties>
</file>